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1" r:id="rId2"/>
    <p:sldId id="263" r:id="rId3"/>
    <p:sldId id="264" r:id="rId4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66FF"/>
    <a:srgbClr val="0000FF"/>
    <a:srgbClr val="FF9999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18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039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793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81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75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171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847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166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383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417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459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80D690-5EDD-43A6-B0CB-CA7121D28864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E7278E-85D3-458B-9B05-CB4BF87AD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746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5952865D-F0AB-EC04-9670-F4CB32BBC8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445"/>
          <a:stretch>
            <a:fillRect/>
          </a:stretch>
        </p:blipFill>
        <p:spPr>
          <a:xfrm>
            <a:off x="2950464" y="4123220"/>
            <a:ext cx="5327904" cy="4342123"/>
          </a:xfrm>
          <a:prstGeom prst="rect">
            <a:avLst/>
          </a:prstGeom>
        </p:spPr>
      </p:pic>
      <p:pic>
        <p:nvPicPr>
          <p:cNvPr id="7" name="Picture 6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CCF1FB05-E021-CACB-5B33-B61B47C2B4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0464" y="2497"/>
            <a:ext cx="5327904" cy="39320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D254427-EBD5-54AC-89B6-886CAD22409D}"/>
              </a:ext>
            </a:extLst>
          </p:cNvPr>
          <p:cNvSpPr txBox="1"/>
          <p:nvPr/>
        </p:nvSpPr>
        <p:spPr>
          <a:xfrm>
            <a:off x="2762656" y="0"/>
            <a:ext cx="3756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BE736CC-0372-6F85-84DE-53905A44B2BB}"/>
              </a:ext>
            </a:extLst>
          </p:cNvPr>
          <p:cNvSpPr txBox="1"/>
          <p:nvPr/>
        </p:nvSpPr>
        <p:spPr>
          <a:xfrm>
            <a:off x="2767786" y="3988463"/>
            <a:ext cx="3704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DB65AF4-FF77-87D3-66AF-DF2877FC4FB5}"/>
              </a:ext>
            </a:extLst>
          </p:cNvPr>
          <p:cNvSpPr txBox="1"/>
          <p:nvPr/>
        </p:nvSpPr>
        <p:spPr>
          <a:xfrm>
            <a:off x="2950464" y="8654035"/>
            <a:ext cx="5611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Figure S1: DESeq2 output figures. (A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PCA plot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B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Heatmap.</a:t>
            </a:r>
          </a:p>
        </p:txBody>
      </p:sp>
    </p:spTree>
    <p:extLst>
      <p:ext uri="{BB962C8B-B14F-4D97-AF65-F5344CB8AC3E}">
        <p14:creationId xmlns:p14="http://schemas.microsoft.com/office/powerpoint/2010/main" val="3516507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7BF7C23-C0DA-C72D-2F99-4D6B6A267E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"/>
            <a:ext cx="9375648" cy="87150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7BB3087-06BF-F82F-A42D-B86D0A0D6744}"/>
              </a:ext>
            </a:extLst>
          </p:cNvPr>
          <p:cNvSpPr txBox="1"/>
          <p:nvPr/>
        </p:nvSpPr>
        <p:spPr>
          <a:xfrm>
            <a:off x="0" y="8805446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Figure S2: “TGF-BETA signaling pathway”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. In red: upregulated DE genes, in blue: downregulated DE genes.</a:t>
            </a:r>
          </a:p>
        </p:txBody>
      </p:sp>
    </p:spTree>
    <p:extLst>
      <p:ext uri="{BB962C8B-B14F-4D97-AF65-F5344CB8AC3E}">
        <p14:creationId xmlns:p14="http://schemas.microsoft.com/office/powerpoint/2010/main" val="1798336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31C767D-7EEE-A5E4-AE3E-E844BD0AD0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8" y="2547742"/>
            <a:ext cx="3682207" cy="2156070"/>
          </a:xfrm>
          <a:prstGeom prst="rect">
            <a:avLst/>
          </a:prstGeom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AA73C6F-7E23-A813-3769-00408E558D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7126" y="2763179"/>
            <a:ext cx="3920072" cy="2161965"/>
          </a:xfrm>
          <a:prstGeom prst="rect">
            <a:avLst/>
          </a:prstGeom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631F003-49D7-F957-2DF7-6542B0879A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1555" y="2608702"/>
            <a:ext cx="3002668" cy="2111654"/>
          </a:xfrm>
          <a:prstGeom prst="rect">
            <a:avLst/>
          </a:prstGeom>
          <a:ln>
            <a:noFill/>
          </a:ln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D0F7D2F0-BA7E-2CFB-560E-F9F4F65124D5}"/>
              </a:ext>
            </a:extLst>
          </p:cNvPr>
          <p:cNvCxnSpPr>
            <a:cxnSpLocks/>
          </p:cNvCxnSpPr>
          <p:nvPr/>
        </p:nvCxnSpPr>
        <p:spPr>
          <a:xfrm>
            <a:off x="3114224" y="2805576"/>
            <a:ext cx="0" cy="1583157"/>
          </a:xfrm>
          <a:prstGeom prst="line">
            <a:avLst/>
          </a:prstGeom>
          <a:ln w="9525">
            <a:noFill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65D81762-9364-5FB7-89CD-92E4A10287E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1555" y="71393"/>
            <a:ext cx="2958768" cy="2384745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A0699CA-8FC7-D52F-16E5-1AA75E7E746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13" y="110712"/>
            <a:ext cx="3568446" cy="2384745"/>
          </a:xfrm>
          <a:prstGeom prst="rect">
            <a:avLst/>
          </a:prstGeom>
          <a:ln>
            <a:noFill/>
          </a:ln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AF7ACFF-3708-AEF3-681B-F0CF85A7F38E}"/>
              </a:ext>
            </a:extLst>
          </p:cNvPr>
          <p:cNvCxnSpPr>
            <a:cxnSpLocks/>
          </p:cNvCxnSpPr>
          <p:nvPr/>
        </p:nvCxnSpPr>
        <p:spPr>
          <a:xfrm>
            <a:off x="1565223" y="912300"/>
            <a:ext cx="0" cy="1583157"/>
          </a:xfrm>
          <a:prstGeom prst="line">
            <a:avLst/>
          </a:prstGeom>
          <a:ln w="9525">
            <a:noFill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14E2B94-4E93-9500-81A9-9D77BD2FF949}"/>
              </a:ext>
            </a:extLst>
          </p:cNvPr>
          <p:cNvSpPr txBox="1"/>
          <p:nvPr/>
        </p:nvSpPr>
        <p:spPr>
          <a:xfrm>
            <a:off x="0" y="14535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9FFA053-3020-13F5-F771-02E63AEFA8FE}"/>
              </a:ext>
            </a:extLst>
          </p:cNvPr>
          <p:cNvSpPr txBox="1"/>
          <p:nvPr/>
        </p:nvSpPr>
        <p:spPr>
          <a:xfrm>
            <a:off x="4001047" y="14535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7AD4CE-C908-DA00-414A-5958D23E51A6}"/>
              </a:ext>
            </a:extLst>
          </p:cNvPr>
          <p:cNvSpPr txBox="1"/>
          <p:nvPr/>
        </p:nvSpPr>
        <p:spPr>
          <a:xfrm>
            <a:off x="7978414" y="14944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D05FA2-F117-C9CE-2DDB-924929EA92DD}"/>
              </a:ext>
            </a:extLst>
          </p:cNvPr>
          <p:cNvSpPr txBox="1"/>
          <p:nvPr/>
        </p:nvSpPr>
        <p:spPr>
          <a:xfrm>
            <a:off x="0" y="2513653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D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1739EB7-DE86-6A8C-974E-D6237C63A1E9}"/>
              </a:ext>
            </a:extLst>
          </p:cNvPr>
          <p:cNvSpPr txBox="1"/>
          <p:nvPr/>
        </p:nvSpPr>
        <p:spPr>
          <a:xfrm>
            <a:off x="3991311" y="2623636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601227-C193-C453-15B0-4169C6D033DE}"/>
              </a:ext>
            </a:extLst>
          </p:cNvPr>
          <p:cNvSpPr txBox="1"/>
          <p:nvPr/>
        </p:nvSpPr>
        <p:spPr>
          <a:xfrm>
            <a:off x="7729940" y="2593902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2BB3B78-C60A-DBA9-6A36-9777DFEB1E1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8414" y="427721"/>
            <a:ext cx="3908784" cy="215573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885AE93-24D7-D86D-672D-905EB728B44B}"/>
              </a:ext>
            </a:extLst>
          </p:cNvPr>
          <p:cNvSpPr txBox="1"/>
          <p:nvPr/>
        </p:nvSpPr>
        <p:spPr>
          <a:xfrm>
            <a:off x="0" y="7559621"/>
            <a:ext cx="12192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Figure S3: KLF4 in fibroblast subtypes in 2 </a:t>
            </a:r>
            <a:r>
              <a:rPr lang="en-US" sz="1600" b="1" i="1">
                <a:latin typeface="Cambria" panose="02040503050406030204" pitchFamily="18" charset="0"/>
                <a:ea typeface="Cambria" panose="02040503050406030204" pitchFamily="18" charset="0"/>
              </a:rPr>
              <a:t>single cell RNAseq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datasets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A-C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Based on Tsukui et al. 2024 dataset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A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Fibroblast subtypes in normal (NML, n=3) and SSc-ILD lungs (SCD, n=2)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B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KLF4 levels by subtype and condition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C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Fibroblast subtype proportions in NML and SCD lungs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D-F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Based on </a:t>
            </a:r>
            <a:r>
              <a:rPr lang="en-US" sz="1600" i="1" dirty="0" err="1">
                <a:latin typeface="Cambria" panose="02040503050406030204" pitchFamily="18" charset="0"/>
                <a:ea typeface="Cambria" panose="02040503050406030204" pitchFamily="18" charset="0"/>
              </a:rPr>
              <a:t>Valenzi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 et al. 2019 dataset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D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Fibroblast subtypes in normal (NML, n=5 lobes from 4 donors) and SSc-ILD lungs (SCD, n=8 lobes from 4 patients)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E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KLF4 levels by subtype and condition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F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Fibroblast subtype proportions in NML and SCD lungs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G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Weighted KLF4 contribution per fibroblast subtype in </a:t>
            </a:r>
            <a:r>
              <a:rPr lang="en-US" sz="1600" i="1" dirty="0" err="1">
                <a:latin typeface="Cambria" panose="02040503050406030204" pitchFamily="18" charset="0"/>
                <a:ea typeface="Cambria" panose="02040503050406030204" pitchFamily="18" charset="0"/>
              </a:rPr>
              <a:t>Valenzi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 et al. [15]</a:t>
            </a:r>
            <a:r>
              <a:rPr lang="fi-FI" sz="1600" dirty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sz="1600" i="1" dirty="0" err="1">
                <a:latin typeface="Cambria" panose="02040503050406030204" pitchFamily="18" charset="0"/>
                <a:ea typeface="Cambria" panose="02040503050406030204" pitchFamily="18" charset="0"/>
              </a:rPr>
              <a:t>scRNAseq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 dataset in normal (NOR) and SSc-ILD lungs (SSC) using subtype markers defined by Tsukui et al. [16]. </a:t>
            </a:r>
            <a:r>
              <a:rPr lang="en-US" sz="1600" b="1" i="1" dirty="0">
                <a:latin typeface="Cambria" panose="02040503050406030204" pitchFamily="18" charset="0"/>
                <a:ea typeface="Cambria" panose="02040503050406030204" pitchFamily="18" charset="0"/>
              </a:rPr>
              <a:t>(H) 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Total fibroblast KLF4 load in NOR and SSC lungs in </a:t>
            </a:r>
            <a:r>
              <a:rPr lang="en-US" sz="1600" i="1" dirty="0" err="1">
                <a:latin typeface="Cambria" panose="02040503050406030204" pitchFamily="18" charset="0"/>
                <a:ea typeface="Cambria" panose="02040503050406030204" pitchFamily="18" charset="0"/>
              </a:rPr>
              <a:t>Valenzi</a:t>
            </a:r>
            <a:r>
              <a:rPr lang="en-US" sz="1600" i="1" dirty="0">
                <a:latin typeface="Cambria" panose="02040503050406030204" pitchFamily="18" charset="0"/>
                <a:ea typeface="Cambria" panose="02040503050406030204" pitchFamily="18" charset="0"/>
              </a:rPr>
              <a:t> et al. dataset.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0B137E3-327C-7CBA-FCFD-57F239E32E9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64" y="5125255"/>
            <a:ext cx="3338995" cy="2127377"/>
          </a:xfrm>
          <a:prstGeom prst="rect">
            <a:avLst/>
          </a:prstGeom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799B0E0-6242-31A7-34D7-0861AC89234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0882" y="5146784"/>
            <a:ext cx="2550593" cy="1851424"/>
          </a:xfrm>
          <a:prstGeom prst="rect">
            <a:avLst/>
          </a:prstGeom>
          <a:ln>
            <a:noFill/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C66CE8E-F848-CFD4-82B6-3DCF72E51DCC}"/>
              </a:ext>
            </a:extLst>
          </p:cNvPr>
          <p:cNvSpPr txBox="1"/>
          <p:nvPr/>
        </p:nvSpPr>
        <p:spPr>
          <a:xfrm>
            <a:off x="-1446" y="4770243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6047F2F-3C3A-0DA7-8BE7-EA477F133710}"/>
              </a:ext>
            </a:extLst>
          </p:cNvPr>
          <p:cNvSpPr txBox="1"/>
          <p:nvPr/>
        </p:nvSpPr>
        <p:spPr>
          <a:xfrm>
            <a:off x="4273631" y="4740509"/>
            <a:ext cx="474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H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262804E-A86F-0356-8DC2-57BA172AF148}"/>
              </a:ext>
            </a:extLst>
          </p:cNvPr>
          <p:cNvSpPr txBox="1"/>
          <p:nvPr/>
        </p:nvSpPr>
        <p:spPr>
          <a:xfrm>
            <a:off x="4895076" y="4824104"/>
            <a:ext cx="137569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Total fibroblast KLF4 load</a:t>
            </a:r>
          </a:p>
        </p:txBody>
      </p:sp>
    </p:spTree>
    <p:extLst>
      <p:ext uri="{BB962C8B-B14F-4D97-AF65-F5344CB8AC3E}">
        <p14:creationId xmlns:p14="http://schemas.microsoft.com/office/powerpoint/2010/main" val="3078803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63</TotalTime>
  <Words>263</Words>
  <Application>Microsoft Office PowerPoint</Application>
  <PresentationFormat>Custom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Arial Narrow</vt:lpstr>
      <vt:lpstr>Cambria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naud, Ludivine</dc:creator>
  <cp:lastModifiedBy>Renaud, Ludivine</cp:lastModifiedBy>
  <cp:revision>59</cp:revision>
  <dcterms:created xsi:type="dcterms:W3CDTF">2025-08-14T17:40:30Z</dcterms:created>
  <dcterms:modified xsi:type="dcterms:W3CDTF">2026-04-29T12:23:12Z</dcterms:modified>
</cp:coreProperties>
</file>